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0"/>
  </p:notesMasterIdLst>
  <p:sldIdLst>
    <p:sldId id="257" r:id="rId2"/>
    <p:sldId id="258" r:id="rId3"/>
    <p:sldId id="261" r:id="rId4"/>
    <p:sldId id="265" r:id="rId5"/>
    <p:sldId id="260" r:id="rId6"/>
    <p:sldId id="263" r:id="rId7"/>
    <p:sldId id="262" r:id="rId8"/>
    <p:sldId id="264" r:id="rId9"/>
  </p:sldIdLst>
  <p:sldSz cx="12192000" cy="6858000"/>
  <p:notesSz cx="6858000" cy="9144000"/>
  <p:defaultTextStyle>
    <a:defPPr>
      <a:defRPr lang="en-NA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6078"/>
    <p:restoredTop sz="79958" autoAdjust="0"/>
  </p:normalViewPr>
  <p:slideViewPr>
    <p:cSldViewPr snapToGrid="0">
      <p:cViewPr varScale="1">
        <p:scale>
          <a:sx n="97" d="100"/>
          <a:sy n="97" d="100"/>
        </p:scale>
        <p:origin x="77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N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ABC8773-A485-4046-9092-95C0E7BE7174}" type="datetimeFigureOut">
              <a:rPr lang="en-NA" smtClean="0"/>
              <a:t>7/5/24</a:t>
            </a:fld>
            <a:endParaRPr lang="en-N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N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N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N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FF4BD2A-5EE3-0F47-B8A0-9A5EACF07D91}" type="slidenum">
              <a:rPr lang="en-NA" smtClean="0"/>
              <a:t>‹#›</a:t>
            </a:fld>
            <a:endParaRPr lang="en-NA"/>
          </a:p>
        </p:txBody>
      </p:sp>
    </p:spTree>
    <p:extLst>
      <p:ext uri="{BB962C8B-B14F-4D97-AF65-F5344CB8AC3E}">
        <p14:creationId xmlns:p14="http://schemas.microsoft.com/office/powerpoint/2010/main" val="30730814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NA" dirty="0"/>
              <a:t>Table 1: </a:t>
            </a:r>
            <a:r>
              <a:rPr lang="en-GB" sz="1800" b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List of Primary antibodies used in this study</a:t>
            </a:r>
            <a:r>
              <a:rPr lang="en-NA" b="0" dirty="0">
                <a:effectLst/>
              </a:rPr>
              <a:t> </a:t>
            </a:r>
            <a:endParaRPr lang="en-NA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FF4BD2A-5EE3-0F47-B8A0-9A5EACF07D91}" type="slidenum">
              <a:rPr lang="en-NA" smtClean="0"/>
              <a:t>1</a:t>
            </a:fld>
            <a:endParaRPr lang="en-NA"/>
          </a:p>
        </p:txBody>
      </p:sp>
    </p:spTree>
    <p:extLst>
      <p:ext uri="{BB962C8B-B14F-4D97-AF65-F5344CB8AC3E}">
        <p14:creationId xmlns:p14="http://schemas.microsoft.com/office/powerpoint/2010/main" val="7830229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NA" dirty="0"/>
              <a:t>Table 2</a:t>
            </a:r>
            <a:r>
              <a:rPr lang="en-NA" b="1" dirty="0"/>
              <a:t>: </a:t>
            </a:r>
            <a:r>
              <a:rPr lang="en-GB" sz="1800" b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List of secondary antibodies used in this study</a:t>
            </a:r>
            <a:r>
              <a:rPr lang="en-NA" b="0" dirty="0">
                <a:effectLst/>
              </a:rPr>
              <a:t> </a:t>
            </a:r>
            <a:endParaRPr lang="en-NA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FF4BD2A-5EE3-0F47-B8A0-9A5EACF07D91}" type="slidenum">
              <a:rPr lang="en-NA" smtClean="0"/>
              <a:t>2</a:t>
            </a:fld>
            <a:endParaRPr lang="en-NA"/>
          </a:p>
        </p:txBody>
      </p:sp>
    </p:spTree>
    <p:extLst>
      <p:ext uri="{BB962C8B-B14F-4D97-AF65-F5344CB8AC3E}">
        <p14:creationId xmlns:p14="http://schemas.microsoft.com/office/powerpoint/2010/main" val="80403417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sz="1800" b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ary Figure</a:t>
            </a:r>
            <a:r>
              <a:rPr lang="en-GB" sz="1800" b="0" dirty="0">
                <a:solidFill>
                  <a:srgbClr val="FFFFFF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1</a:t>
            </a:r>
            <a:r>
              <a:rPr lang="en-GB" sz="1800" b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: Representative image demonstrating the image processing steps carried out in order to analyse the relative expression of a protein of interest relative to the scratch boundary. </a:t>
            </a:r>
            <a:endParaRPr lang="en-NA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FF4BD2A-5EE3-0F47-B8A0-9A5EACF07D91}" type="slidenum">
              <a:rPr lang="en-NA" smtClean="0"/>
              <a:t>3</a:t>
            </a:fld>
            <a:endParaRPr lang="en-NA"/>
          </a:p>
        </p:txBody>
      </p:sp>
    </p:spTree>
    <p:extLst>
      <p:ext uri="{BB962C8B-B14F-4D97-AF65-F5344CB8AC3E}">
        <p14:creationId xmlns:p14="http://schemas.microsoft.com/office/powerpoint/2010/main" val="214789434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ZA" dirty="0"/>
              <a:t>Supplementary Figure 2: Progression of proliferation of N2A cells under normal light microscopy. (A) 30% confluency, (B) 50% confluency, (C) 70% confluency and (D) 90% confluency at (1) 10x magnification and (2) 20X magnification.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FF4BD2A-5EE3-0F47-B8A0-9A5EACF07D91}" type="slidenum">
              <a:rPr lang="en-NA" smtClean="0"/>
              <a:t>4</a:t>
            </a:fld>
            <a:endParaRPr lang="en-NA"/>
          </a:p>
        </p:txBody>
      </p:sp>
    </p:spTree>
    <p:extLst>
      <p:ext uri="{BB962C8B-B14F-4D97-AF65-F5344CB8AC3E}">
        <p14:creationId xmlns:p14="http://schemas.microsoft.com/office/powerpoint/2010/main" val="274603357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3" name="Notes Placeholder 2"/>
              <p:cNvSpPr>
                <a:spLocks noGrp="1"/>
              </p:cNvSpPr>
              <p:nvPr>
                <p:ph type="body" idx="1"/>
              </p:nvPr>
            </p:nvSpPr>
            <p:spPr/>
            <p:txBody>
              <a:bodyPr/>
              <a:lstStyle/>
              <a:p>
                <a:pPr algn="just">
                  <a:spcAft>
                    <a:spcPts val="1000"/>
                  </a:spcAft>
                </a:pPr>
                <a:r>
                  <a:rPr lang="en-GB" sz="1200" b="0" i="0" u="none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Supplementary</a:t>
                </a:r>
                <a:r>
                  <a:rPr lang="en-GB" sz="1200" b="0" i="0" u="none" baseline="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 Figure 3:</a:t>
                </a:r>
                <a:r>
                  <a:rPr lang="en-GB" sz="1200" b="0" i="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 Effect of AF16 on N2A cell viability. Cells were treated with 0.1, 1, 2, 5, 10 and 20μM</a:t>
                </a:r>
                <a:r>
                  <a:rPr lang="en-GB" sz="1200" b="0" i="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 AF16 peptide for 24 hours. Reductive capacity of cells was measured as a percentage of control cells using a WST-1 assay. All results are presented as mean </a:t>
                </a:r>
                <a14:m>
                  <m:oMath xmlns:m="http://schemas.openxmlformats.org/officeDocument/2006/math">
                    <m:r>
                      <a:rPr lang="en-GB" sz="1200" b="0" i="1">
                        <a:solidFill>
                          <a:srgbClr val="000000"/>
                        </a:solidFill>
                        <a:effectLst/>
                        <a:latin typeface="Cambria Math" panose="020405030504060302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m:t>±</m:t>
                    </m:r>
                  </m:oMath>
                </a14:m>
                <a:r>
                  <a:rPr lang="en-GB" sz="1200" b="0" i="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 SEM. n=3, with 6 replicates per group</a:t>
                </a:r>
                <a:endParaRPr lang="en-NA" sz="1000" b="0" i="1" dirty="0">
                  <a:solidFill>
                    <a:srgbClr val="44546A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</mc:Choice>
        <mc:Fallback xmlns="">
          <p:sp>
            <p:nvSpPr>
              <p:cNvPr id="3" name="Notes Placeholder 2"/>
              <p:cNvSpPr>
                <a:spLocks noGrp="1"/>
              </p:cNvSpPr>
              <p:nvPr>
                <p:ph type="body" idx="1"/>
              </p:nvPr>
            </p:nvSpPr>
            <p:spPr/>
            <p:txBody>
              <a:bodyPr/>
              <a:lstStyle/>
              <a:p>
                <a:pPr algn="just">
                  <a:spcAft>
                    <a:spcPts val="1000"/>
                  </a:spcAft>
                </a:pPr>
                <a:r>
                  <a:rPr lang="en-GB" sz="1200" b="0" i="0" u="none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Supplementary</a:t>
                </a:r>
                <a:r>
                  <a:rPr lang="en-GB" sz="1200" b="0" i="0" u="none" baseline="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 Figure 3:</a:t>
                </a:r>
                <a:r>
                  <a:rPr lang="en-GB" sz="1200" b="0" i="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 Effect of AF16 on N2A cell viability. Cells were treated with 0.1, 1, 2, 5, 10 and 20μM</a:t>
                </a:r>
                <a:r>
                  <a:rPr lang="en-GB" sz="1200" b="0" i="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 AF16 peptide for 24 hours. Reductive capacity of cells was measured as a percentage of control cells using a WST-1 assay. All results are presented as mean </a:t>
                </a:r>
                <a:r>
                  <a:rPr lang="en-GB" sz="1200" b="0" i="0">
                    <a:solidFill>
                      <a:srgbClr val="000000"/>
                    </a:solidFill>
                    <a:effectLst/>
                    <a:latin typeface="Cambria Math" panose="020405030504060302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±</a:t>
                </a:r>
                <a:r>
                  <a:rPr lang="en-GB" sz="1200" b="0" i="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 SEM. n=3, with 6 replicates per group</a:t>
                </a:r>
                <a:endParaRPr lang="en-NA" sz="1000" b="0" i="1" dirty="0">
                  <a:solidFill>
                    <a:srgbClr val="44546A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</mc:Fallback>
      </mc:AlternateContent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FF4BD2A-5EE3-0F47-B8A0-9A5EACF07D91}" type="slidenum">
              <a:rPr lang="en-NA" smtClean="0"/>
              <a:t>5</a:t>
            </a:fld>
            <a:endParaRPr lang="en-NA"/>
          </a:p>
        </p:txBody>
      </p:sp>
    </p:spTree>
    <p:extLst>
      <p:ext uri="{BB962C8B-B14F-4D97-AF65-F5344CB8AC3E}">
        <p14:creationId xmlns:p14="http://schemas.microsoft.com/office/powerpoint/2010/main" val="4082379588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1" i="0" u="non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4: </a:t>
            </a:r>
            <a:r>
              <a:rPr lang="en-GB" sz="1200" b="1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ltrastructural analysis of organelles in control cells and upon exposure with AF16 using Field Emission Scanning Electron Microscopy (FESEM). </a:t>
            </a:r>
            <a:r>
              <a:rPr lang="en-GB" sz="12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1-3) Control cells and B1-3) AF16 treated cells.  M – mitochondria; </a:t>
            </a:r>
            <a:r>
              <a:rPr lang="en-GB" sz="1200" i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s</a:t>
            </a:r>
            <a:r>
              <a:rPr lang="en-GB" sz="12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– swollen mitochondria; </a:t>
            </a:r>
            <a:r>
              <a:rPr lang="en-GB" sz="1200" i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r</a:t>
            </a:r>
            <a:r>
              <a:rPr lang="en-GB" sz="12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– ruptured mitochondria; mi – irregular mitochondria; arrows – horseshoe shaped mitochondria; square – ROI of interest containing electron dense structures within the ER.</a:t>
            </a:r>
            <a:endParaRPr lang="en-NA" sz="1000" i="1" dirty="0">
              <a:solidFill>
                <a:srgbClr val="44546A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NA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FF4BD2A-5EE3-0F47-B8A0-9A5EACF07D91}" type="slidenum">
              <a:rPr lang="en-NA" smtClean="0"/>
              <a:t>6</a:t>
            </a:fld>
            <a:endParaRPr lang="en-NA"/>
          </a:p>
        </p:txBody>
      </p:sp>
    </p:spTree>
    <p:extLst>
      <p:ext uri="{BB962C8B-B14F-4D97-AF65-F5344CB8AC3E}">
        <p14:creationId xmlns:p14="http://schemas.microsoft.com/office/powerpoint/2010/main" val="2118737593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sz="1200" b="1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5: Correlative Light and Electron Microscopy (CLEM) of control N2A cells. </a:t>
            </a:r>
            <a:r>
              <a:rPr lang="en-GB" sz="12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presentative electron, fluorescence and overlay micrographs of control N2A cells. A) SEM micrograph of control N2A</a:t>
            </a:r>
            <a:r>
              <a:rPr lang="en-GB" sz="1200" i="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ell. B) Confocal fluorescent micrograph of N2A cell at 100x magnification post image transformation. C) Overlayed image of the images seen in A and B. D) FITC-AF16, E) Lysotracker Red, F) Mitotracker Deep Red and G) overlayed images of the region of interest outlined in C, with the corresponding overlay of these channels displayed in H-J. K) FESEM image of the ROI in C. White arrows indicate mitochondria. Scale bar is 1</a:t>
            </a:r>
            <a:r>
              <a:rPr lang="en-GB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μm</a:t>
            </a:r>
            <a:endParaRPr lang="en-NA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FF4BD2A-5EE3-0F47-B8A0-9A5EACF07D91}" type="slidenum">
              <a:rPr lang="en-NA" smtClean="0"/>
              <a:t>7</a:t>
            </a:fld>
            <a:endParaRPr lang="en-NA"/>
          </a:p>
        </p:txBody>
      </p:sp>
    </p:spTree>
    <p:extLst>
      <p:ext uri="{BB962C8B-B14F-4D97-AF65-F5344CB8AC3E}">
        <p14:creationId xmlns:p14="http://schemas.microsoft.com/office/powerpoint/2010/main" val="4242936180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sz="1200" b="1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6: Correlative Light and Electron Microscopy (CLEM) of control N2A cells upon AF16 exposure. </a:t>
            </a:r>
            <a:r>
              <a:rPr lang="en-GB" sz="12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presentative electron, fluorescence and overlay micrographs of N2A cells treated with 10μM AF16. A) SEM micrograph of FITC-AF16 treated N2A</a:t>
            </a:r>
            <a:r>
              <a:rPr lang="en-GB" sz="1200" i="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ell. B) Confocal fluorescent micrograph of N2A cell at 100x magnification post image transformation. C) Overlayed image of the images seen in A and B. D) FITC-AF16, E) Lysotracker Red, F) Mitotracker Deep Red and G) overlayed images of the region of interest outlined in C, with the corresponding overlay of these channels displayed in H-J. K) FESEM image of the ROI in C. White arrows indicate mitochondria. Scale bar is 1</a:t>
            </a:r>
            <a:r>
              <a:rPr lang="en-GB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μm</a:t>
            </a:r>
            <a:endParaRPr lang="en-NA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FF4BD2A-5EE3-0F47-B8A0-9A5EACF07D91}" type="slidenum">
              <a:rPr lang="en-NA" smtClean="0"/>
              <a:t>8</a:t>
            </a:fld>
            <a:endParaRPr lang="en-NA"/>
          </a:p>
        </p:txBody>
      </p:sp>
    </p:spTree>
    <p:extLst>
      <p:ext uri="{BB962C8B-B14F-4D97-AF65-F5344CB8AC3E}">
        <p14:creationId xmlns:p14="http://schemas.microsoft.com/office/powerpoint/2010/main" val="54363308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9AE757-C3BE-252F-A00F-99816B02B3D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N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CA4EF6B-A7F7-BBBC-AECF-6B3A6C3BD27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N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923B9C-86C8-F1D8-3F34-739C03175B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93845-8525-3B47-B38A-AF2ADCBE5F38}" type="datetimeFigureOut">
              <a:rPr lang="en-NA" smtClean="0"/>
              <a:t>7/5/24</a:t>
            </a:fld>
            <a:endParaRPr lang="en-N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7AAF8B-3588-CA1F-69CE-98E716DBFF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BF6C48-6770-9132-74B6-ECDEB55E31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6238F-52C0-894A-B6DB-8DF464F9C569}" type="slidenum">
              <a:rPr lang="en-NA" smtClean="0"/>
              <a:t>‹#›</a:t>
            </a:fld>
            <a:endParaRPr lang="en-NA"/>
          </a:p>
        </p:txBody>
      </p:sp>
    </p:spTree>
    <p:extLst>
      <p:ext uri="{BB962C8B-B14F-4D97-AF65-F5344CB8AC3E}">
        <p14:creationId xmlns:p14="http://schemas.microsoft.com/office/powerpoint/2010/main" val="34020368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53B067-553C-1D2F-6AE2-CAA143F138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N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C56121E-58EB-7065-DD24-97F1660C88B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N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F68F1C-FD43-52AE-C316-D79642D1C3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93845-8525-3B47-B38A-AF2ADCBE5F38}" type="datetimeFigureOut">
              <a:rPr lang="en-NA" smtClean="0"/>
              <a:t>7/5/24</a:t>
            </a:fld>
            <a:endParaRPr lang="en-N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0D095C-A2BD-B521-9365-CA7D1FBC76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B86114-EECA-289C-C158-218E0427D4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6238F-52C0-894A-B6DB-8DF464F9C569}" type="slidenum">
              <a:rPr lang="en-NA" smtClean="0"/>
              <a:t>‹#›</a:t>
            </a:fld>
            <a:endParaRPr lang="en-NA"/>
          </a:p>
        </p:txBody>
      </p:sp>
    </p:spTree>
    <p:extLst>
      <p:ext uri="{BB962C8B-B14F-4D97-AF65-F5344CB8AC3E}">
        <p14:creationId xmlns:p14="http://schemas.microsoft.com/office/powerpoint/2010/main" val="13110131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04ECEF2-781C-A3FC-A1DC-D7F73F37CDF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N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9EA8377-5BDF-A654-13DC-E5C9BCDB88C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N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B82E35-8F3C-C0C6-FC54-A91742B914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93845-8525-3B47-B38A-AF2ADCBE5F38}" type="datetimeFigureOut">
              <a:rPr lang="en-NA" smtClean="0"/>
              <a:t>7/5/24</a:t>
            </a:fld>
            <a:endParaRPr lang="en-N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4599A7-4268-070B-3437-F7059818F4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B7E1F4-225F-013D-0A09-6A0A30EBCE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6238F-52C0-894A-B6DB-8DF464F9C569}" type="slidenum">
              <a:rPr lang="en-NA" smtClean="0"/>
              <a:t>‹#›</a:t>
            </a:fld>
            <a:endParaRPr lang="en-NA"/>
          </a:p>
        </p:txBody>
      </p:sp>
    </p:spTree>
    <p:extLst>
      <p:ext uri="{BB962C8B-B14F-4D97-AF65-F5344CB8AC3E}">
        <p14:creationId xmlns:p14="http://schemas.microsoft.com/office/powerpoint/2010/main" val="1711142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B76EBD-E848-25D0-8BB5-077D006C84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N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3524544-4FCA-9490-3012-429E7444D72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N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051226-21A3-5459-0498-65DBBA5037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93845-8525-3B47-B38A-AF2ADCBE5F38}" type="datetimeFigureOut">
              <a:rPr lang="en-NA" smtClean="0"/>
              <a:t>7/5/24</a:t>
            </a:fld>
            <a:endParaRPr lang="en-N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5D6191-FA29-F84F-4904-98AC51057E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884841-F5BB-CCBE-E3A3-23EC95E83D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6238F-52C0-894A-B6DB-8DF464F9C569}" type="slidenum">
              <a:rPr lang="en-NA" smtClean="0"/>
              <a:t>‹#›</a:t>
            </a:fld>
            <a:endParaRPr lang="en-NA"/>
          </a:p>
        </p:txBody>
      </p:sp>
    </p:spTree>
    <p:extLst>
      <p:ext uri="{BB962C8B-B14F-4D97-AF65-F5344CB8AC3E}">
        <p14:creationId xmlns:p14="http://schemas.microsoft.com/office/powerpoint/2010/main" val="20425126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F7E182-76CD-8303-EDFD-EEBB3DBA05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N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613B5B0-C8FD-786F-3DF7-0ED487AD9D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8B503B-A667-DFAC-A306-0CA50CDE9A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93845-8525-3B47-B38A-AF2ADCBE5F38}" type="datetimeFigureOut">
              <a:rPr lang="en-NA" smtClean="0"/>
              <a:t>7/5/24</a:t>
            </a:fld>
            <a:endParaRPr lang="en-N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152CB6-47C9-1084-CB30-3FCC669CB4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313B45-5D88-8DAE-E639-364A2E2058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6238F-52C0-894A-B6DB-8DF464F9C569}" type="slidenum">
              <a:rPr lang="en-NA" smtClean="0"/>
              <a:t>‹#›</a:t>
            </a:fld>
            <a:endParaRPr lang="en-NA"/>
          </a:p>
        </p:txBody>
      </p:sp>
    </p:spTree>
    <p:extLst>
      <p:ext uri="{BB962C8B-B14F-4D97-AF65-F5344CB8AC3E}">
        <p14:creationId xmlns:p14="http://schemas.microsoft.com/office/powerpoint/2010/main" val="38663605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068679-1BCA-7AF2-97A8-0A6E80737C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N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7A34132-F344-DB9C-A170-E4F9BFEA225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N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DDCF8FE-B548-D604-2794-C708EDE8F3A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N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4A65721-A71E-6D93-3CD4-B2B3AABB75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93845-8525-3B47-B38A-AF2ADCBE5F38}" type="datetimeFigureOut">
              <a:rPr lang="en-NA" smtClean="0"/>
              <a:t>7/5/24</a:t>
            </a:fld>
            <a:endParaRPr lang="en-N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A3DF88D-C29C-BD7B-A29E-F69BE9B2CC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D888DCF-8DB5-16B8-A992-476708CAD0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6238F-52C0-894A-B6DB-8DF464F9C569}" type="slidenum">
              <a:rPr lang="en-NA" smtClean="0"/>
              <a:t>‹#›</a:t>
            </a:fld>
            <a:endParaRPr lang="en-NA"/>
          </a:p>
        </p:txBody>
      </p:sp>
    </p:spTree>
    <p:extLst>
      <p:ext uri="{BB962C8B-B14F-4D97-AF65-F5344CB8AC3E}">
        <p14:creationId xmlns:p14="http://schemas.microsoft.com/office/powerpoint/2010/main" val="37335510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047886-24B4-B0DA-3AFE-96CE39A419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N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96C2F44-ED38-46B6-C2F7-2A55073A88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D20F8F4-CF01-D65C-92B6-6D7466F3759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N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22D54C6-3F1A-1F4F-2069-A2519E18C96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49E320A-B579-443D-8082-AC7BEC4EDFA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N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2F56C46-05CB-9BBD-AB1D-C85DBC03EE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93845-8525-3B47-B38A-AF2ADCBE5F38}" type="datetimeFigureOut">
              <a:rPr lang="en-NA" smtClean="0"/>
              <a:t>7/5/24</a:t>
            </a:fld>
            <a:endParaRPr lang="en-N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12878D8-0CFF-D666-6859-DDC1674C2F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A435D45-C54C-BB25-B221-451DE3305F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6238F-52C0-894A-B6DB-8DF464F9C569}" type="slidenum">
              <a:rPr lang="en-NA" smtClean="0"/>
              <a:t>‹#›</a:t>
            </a:fld>
            <a:endParaRPr lang="en-NA"/>
          </a:p>
        </p:txBody>
      </p:sp>
    </p:spTree>
    <p:extLst>
      <p:ext uri="{BB962C8B-B14F-4D97-AF65-F5344CB8AC3E}">
        <p14:creationId xmlns:p14="http://schemas.microsoft.com/office/powerpoint/2010/main" val="23213992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929F38-561E-3BE9-B8C1-46BF24894A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N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BA8108E-7C81-D956-EFCA-71966FFEAC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93845-8525-3B47-B38A-AF2ADCBE5F38}" type="datetimeFigureOut">
              <a:rPr lang="en-NA" smtClean="0"/>
              <a:t>7/5/24</a:t>
            </a:fld>
            <a:endParaRPr lang="en-N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16236EE-BABC-C60A-3DF7-25290DFC76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15FC365-F266-DD6D-8C34-B51BC85713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6238F-52C0-894A-B6DB-8DF464F9C569}" type="slidenum">
              <a:rPr lang="en-NA" smtClean="0"/>
              <a:t>‹#›</a:t>
            </a:fld>
            <a:endParaRPr lang="en-NA"/>
          </a:p>
        </p:txBody>
      </p:sp>
    </p:spTree>
    <p:extLst>
      <p:ext uri="{BB962C8B-B14F-4D97-AF65-F5344CB8AC3E}">
        <p14:creationId xmlns:p14="http://schemas.microsoft.com/office/powerpoint/2010/main" val="5773282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0E0135C-EED4-D766-D356-9F7735805E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93845-8525-3B47-B38A-AF2ADCBE5F38}" type="datetimeFigureOut">
              <a:rPr lang="en-NA" smtClean="0"/>
              <a:t>7/5/24</a:t>
            </a:fld>
            <a:endParaRPr lang="en-N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0282154-DC3B-E07A-46D7-2D642B300E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9035236-AE7D-3116-6B43-252E5D6D0F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6238F-52C0-894A-B6DB-8DF464F9C569}" type="slidenum">
              <a:rPr lang="en-NA" smtClean="0"/>
              <a:t>‹#›</a:t>
            </a:fld>
            <a:endParaRPr lang="en-NA"/>
          </a:p>
        </p:txBody>
      </p:sp>
    </p:spTree>
    <p:extLst>
      <p:ext uri="{BB962C8B-B14F-4D97-AF65-F5344CB8AC3E}">
        <p14:creationId xmlns:p14="http://schemas.microsoft.com/office/powerpoint/2010/main" val="2512446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3D7688-88FB-BBAE-31B3-CD28F25EDA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N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4968385-7119-6D0F-F631-244460BEEE5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N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3E47BCA-CB21-B42A-90AA-0F66E49DCAD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52F6607-E616-63D7-2884-D21D9394B6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93845-8525-3B47-B38A-AF2ADCBE5F38}" type="datetimeFigureOut">
              <a:rPr lang="en-NA" smtClean="0"/>
              <a:t>7/5/24</a:t>
            </a:fld>
            <a:endParaRPr lang="en-N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67BFB10-2497-F499-59DA-6B60A654B5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A350302-64D2-01C1-CD67-8BFBB7698D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6238F-52C0-894A-B6DB-8DF464F9C569}" type="slidenum">
              <a:rPr lang="en-NA" smtClean="0"/>
              <a:t>‹#›</a:t>
            </a:fld>
            <a:endParaRPr lang="en-NA"/>
          </a:p>
        </p:txBody>
      </p:sp>
    </p:spTree>
    <p:extLst>
      <p:ext uri="{BB962C8B-B14F-4D97-AF65-F5344CB8AC3E}">
        <p14:creationId xmlns:p14="http://schemas.microsoft.com/office/powerpoint/2010/main" val="34212611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8AD955-70B9-508C-66E8-C4DAB0F81D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N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C470995-8EA7-7680-95D5-A9BA15A3519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N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C6E6F4C-E185-7848-AE5D-22DAC2B15CB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307EF5B-F3EF-DC25-7021-0D45F834A2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93845-8525-3B47-B38A-AF2ADCBE5F38}" type="datetimeFigureOut">
              <a:rPr lang="en-NA" smtClean="0"/>
              <a:t>7/5/24</a:t>
            </a:fld>
            <a:endParaRPr lang="en-N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74E1C50-C60D-5CB0-9000-770D377E66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B588587-940B-9723-93E9-2EDA879314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6238F-52C0-894A-B6DB-8DF464F9C569}" type="slidenum">
              <a:rPr lang="en-NA" smtClean="0"/>
              <a:t>‹#›</a:t>
            </a:fld>
            <a:endParaRPr lang="en-NA"/>
          </a:p>
        </p:txBody>
      </p:sp>
    </p:spTree>
    <p:extLst>
      <p:ext uri="{BB962C8B-B14F-4D97-AF65-F5344CB8AC3E}">
        <p14:creationId xmlns:p14="http://schemas.microsoft.com/office/powerpoint/2010/main" val="1732730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08893E8-68A5-DB95-D474-5751B667D9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N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0A8A5A3-71AF-AF04-E997-DB17A3EF65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N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77F427-2125-45F9-8C86-CC16E112772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093845-8525-3B47-B38A-AF2ADCBE5F38}" type="datetimeFigureOut">
              <a:rPr lang="en-NA" smtClean="0"/>
              <a:t>7/5/24</a:t>
            </a:fld>
            <a:endParaRPr lang="en-N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F896DF-B9F6-6D84-68C1-FE1BA83F1A4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876BD7-BC28-6C71-45BC-9AD9B55DE22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46238F-52C0-894A-B6DB-8DF464F9C569}" type="slidenum">
              <a:rPr lang="en-NA" smtClean="0"/>
              <a:t>‹#›</a:t>
            </a:fld>
            <a:endParaRPr lang="en-NA"/>
          </a:p>
        </p:txBody>
      </p:sp>
    </p:spTree>
    <p:extLst>
      <p:ext uri="{BB962C8B-B14F-4D97-AF65-F5344CB8AC3E}">
        <p14:creationId xmlns:p14="http://schemas.microsoft.com/office/powerpoint/2010/main" val="21839628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NA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10" Type="http://schemas.openxmlformats.org/officeDocument/2006/relationships/image" Target="../media/image9.jpg"/><Relationship Id="rId4" Type="http://schemas.openxmlformats.org/officeDocument/2006/relationships/image" Target="../media/image3.jpg"/><Relationship Id="rId9" Type="http://schemas.openxmlformats.org/officeDocument/2006/relationships/image" Target="../media/image8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e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e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e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F71CE452-2331-3282-6F8E-FC58E267872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69254450"/>
              </p:ext>
            </p:extLst>
          </p:nvPr>
        </p:nvGraphicFramePr>
        <p:xfrm>
          <a:off x="457200" y="643466"/>
          <a:ext cx="11393425" cy="5571072"/>
        </p:xfrm>
        <a:graphic>
          <a:graphicData uri="http://schemas.openxmlformats.org/drawingml/2006/table">
            <a:tbl>
              <a:tblPr firstRow="1" firstCol="1" bandRow="1"/>
              <a:tblGrid>
                <a:gridCol w="2644564">
                  <a:extLst>
                    <a:ext uri="{9D8B030D-6E8A-4147-A177-3AD203B41FA5}">
                      <a16:colId xmlns:a16="http://schemas.microsoft.com/office/drawing/2014/main" val="3913626932"/>
                    </a:ext>
                  </a:extLst>
                </a:gridCol>
                <a:gridCol w="3228193">
                  <a:extLst>
                    <a:ext uri="{9D8B030D-6E8A-4147-A177-3AD203B41FA5}">
                      <a16:colId xmlns:a16="http://schemas.microsoft.com/office/drawing/2014/main" val="3747358168"/>
                    </a:ext>
                  </a:extLst>
                </a:gridCol>
                <a:gridCol w="1667123">
                  <a:extLst>
                    <a:ext uri="{9D8B030D-6E8A-4147-A177-3AD203B41FA5}">
                      <a16:colId xmlns:a16="http://schemas.microsoft.com/office/drawing/2014/main" val="2738838367"/>
                    </a:ext>
                  </a:extLst>
                </a:gridCol>
                <a:gridCol w="1102917">
                  <a:extLst>
                    <a:ext uri="{9D8B030D-6E8A-4147-A177-3AD203B41FA5}">
                      <a16:colId xmlns:a16="http://schemas.microsoft.com/office/drawing/2014/main" val="1659142977"/>
                    </a:ext>
                  </a:extLst>
                </a:gridCol>
                <a:gridCol w="1375314">
                  <a:extLst>
                    <a:ext uri="{9D8B030D-6E8A-4147-A177-3AD203B41FA5}">
                      <a16:colId xmlns:a16="http://schemas.microsoft.com/office/drawing/2014/main" val="3488631735"/>
                    </a:ext>
                  </a:extLst>
                </a:gridCol>
                <a:gridCol w="1375314">
                  <a:extLst>
                    <a:ext uri="{9D8B030D-6E8A-4147-A177-3AD203B41FA5}">
                      <a16:colId xmlns:a16="http://schemas.microsoft.com/office/drawing/2014/main" val="2995670043"/>
                    </a:ext>
                  </a:extLst>
                </a:gridCol>
              </a:tblGrid>
              <a:tr h="902298"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rimary Antibodies</a:t>
                      </a:r>
                      <a:endParaRPr lang="en-GB" sz="2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mpany</a:t>
                      </a:r>
                      <a:endParaRPr lang="en-GB" sz="2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ost</a:t>
                      </a:r>
                      <a:endParaRPr lang="en-GB" sz="2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ize (kDa)</a:t>
                      </a:r>
                      <a:endParaRPr lang="en-GB" sz="2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iltuion (WB) </a:t>
                      </a:r>
                      <a:endParaRPr lang="en-GB" sz="2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ilution (IF)</a:t>
                      </a:r>
                      <a:endParaRPr lang="en-GB" sz="2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87660111"/>
                  </a:ext>
                </a:extLst>
              </a:tr>
              <a:tr h="477363"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C3B</a:t>
                      </a:r>
                      <a:endParaRPr lang="en-GB" sz="2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ell Signalling (2775S)</a:t>
                      </a:r>
                      <a:endParaRPr lang="en-GB" sz="2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abbit</a:t>
                      </a:r>
                      <a:endParaRPr lang="en-GB" sz="2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5</a:t>
                      </a:r>
                      <a:endParaRPr lang="en-GB" sz="2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en-GB" sz="2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:200</a:t>
                      </a:r>
                      <a:endParaRPr lang="en-GB" sz="2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51849282"/>
                  </a:ext>
                </a:extLst>
              </a:tr>
              <a:tr h="477363"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leaved-Caspase3</a:t>
                      </a:r>
                      <a:endParaRPr lang="en-GB" sz="2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ell Signalling (9661)</a:t>
                      </a:r>
                      <a:endParaRPr lang="en-GB" sz="2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abbit</a:t>
                      </a:r>
                      <a:endParaRPr lang="en-GB" sz="2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  <a:endParaRPr lang="en-GB" sz="2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en-GB" sz="2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/A</a:t>
                      </a:r>
                      <a:endParaRPr lang="en-GB" sz="2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43005658"/>
                  </a:ext>
                </a:extLst>
              </a:tr>
              <a:tr h="477363"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QSTM1/p62</a:t>
                      </a:r>
                      <a:endParaRPr lang="en-GB" sz="2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ell Signalling (23214S)</a:t>
                      </a:r>
                      <a:endParaRPr lang="en-GB" sz="2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abbit</a:t>
                      </a:r>
                      <a:endParaRPr lang="en-GB" sz="2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2</a:t>
                      </a:r>
                      <a:endParaRPr lang="en-GB" sz="2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en-GB" sz="2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/A</a:t>
                      </a:r>
                      <a:endParaRPr lang="en-GB" sz="2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06917368"/>
                  </a:ext>
                </a:extLst>
              </a:tr>
              <a:tr h="477363"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rp-1</a:t>
                      </a:r>
                      <a:endParaRPr lang="en-GB" sz="2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ell Signalling (5391S)</a:t>
                      </a:r>
                      <a:endParaRPr lang="en-GB" sz="2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abbit </a:t>
                      </a:r>
                      <a:endParaRPr lang="en-GB" sz="2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8-82</a:t>
                      </a:r>
                      <a:endParaRPr lang="en-GB" sz="2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en-GB" sz="2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:200</a:t>
                      </a:r>
                      <a:endParaRPr lang="en-GB" sz="2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72750647"/>
                  </a:ext>
                </a:extLst>
              </a:tr>
              <a:tr h="477363"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FN-1</a:t>
                      </a:r>
                      <a:endParaRPr lang="en-GB" sz="2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bcam (ab57602)</a:t>
                      </a:r>
                      <a:endParaRPr lang="en-GB" sz="2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ouse</a:t>
                      </a:r>
                      <a:endParaRPr lang="en-GB" sz="2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84</a:t>
                      </a:r>
                      <a:endParaRPr lang="en-GB" sz="2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en-GB" sz="2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:200</a:t>
                      </a:r>
                      <a:endParaRPr lang="en-GB" sz="2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52886998"/>
                  </a:ext>
                </a:extLst>
              </a:tr>
              <a:tr h="902298"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-Hydroxy-2-nonenal</a:t>
                      </a:r>
                      <a:endParaRPr lang="en-GB" sz="2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bcam (ab46545)</a:t>
                      </a:r>
                      <a:endParaRPr lang="en-GB" sz="2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abbit</a:t>
                      </a:r>
                      <a:endParaRPr lang="en-GB" sz="2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5-76</a:t>
                      </a:r>
                      <a:endParaRPr lang="en-GB" sz="2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en-GB" sz="2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:200</a:t>
                      </a:r>
                      <a:endParaRPr lang="en-GB" sz="2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45339927"/>
                  </a:ext>
                </a:extLst>
              </a:tr>
              <a:tr h="477363"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9S S5A/ASF</a:t>
                      </a:r>
                      <a:endParaRPr lang="en-GB" sz="2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bcam (ab154934) </a:t>
                      </a:r>
                      <a:endParaRPr lang="en-GB" sz="2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abbit </a:t>
                      </a:r>
                      <a:endParaRPr lang="en-GB" sz="2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0</a:t>
                      </a:r>
                      <a:endParaRPr lang="en-GB" sz="2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en-GB" sz="2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:200</a:t>
                      </a:r>
                      <a:endParaRPr lang="en-GB" sz="2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6046139"/>
                  </a:ext>
                </a:extLst>
              </a:tr>
              <a:tr h="902298"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eclin</a:t>
                      </a:r>
                      <a:endParaRPr lang="en-GB" sz="2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hermoFischer Scientific (OTI1F1)</a:t>
                      </a:r>
                      <a:endParaRPr lang="en-GB" sz="2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ouse</a:t>
                      </a:r>
                      <a:endParaRPr lang="en-GB" sz="2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2</a:t>
                      </a:r>
                      <a:endParaRPr lang="en-GB" sz="2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en-GB" sz="2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900" b="0" i="0" u="none" strike="noStrike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:200</a:t>
                      </a:r>
                      <a:endParaRPr lang="en-GB" sz="2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5519" marR="105519" marT="146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6475949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1383C853-3D83-1E10-E669-E36F7CA473E3}"/>
              </a:ext>
            </a:extLst>
          </p:cNvPr>
          <p:cNvSpPr txBox="1"/>
          <p:nvPr/>
        </p:nvSpPr>
        <p:spPr>
          <a:xfrm>
            <a:off x="206225" y="6488668"/>
            <a:ext cx="2176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able 1</a:t>
            </a:r>
          </a:p>
        </p:txBody>
      </p:sp>
    </p:spTree>
    <p:extLst>
      <p:ext uri="{BB962C8B-B14F-4D97-AF65-F5344CB8AC3E}">
        <p14:creationId xmlns:p14="http://schemas.microsoft.com/office/powerpoint/2010/main" val="33751601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42A37807-7D7A-E0CE-AC0F-A815A43F3AC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18472645"/>
              </p:ext>
            </p:extLst>
          </p:nvPr>
        </p:nvGraphicFramePr>
        <p:xfrm>
          <a:off x="209006" y="643466"/>
          <a:ext cx="11806210" cy="5571074"/>
        </p:xfrm>
        <a:graphic>
          <a:graphicData uri="http://schemas.openxmlformats.org/drawingml/2006/table">
            <a:tbl>
              <a:tblPr firstRow="1" firstCol="1" bandRow="1"/>
              <a:tblGrid>
                <a:gridCol w="3551933">
                  <a:extLst>
                    <a:ext uri="{9D8B030D-6E8A-4147-A177-3AD203B41FA5}">
                      <a16:colId xmlns:a16="http://schemas.microsoft.com/office/drawing/2014/main" val="3664350724"/>
                    </a:ext>
                  </a:extLst>
                </a:gridCol>
                <a:gridCol w="2995197">
                  <a:extLst>
                    <a:ext uri="{9D8B030D-6E8A-4147-A177-3AD203B41FA5}">
                      <a16:colId xmlns:a16="http://schemas.microsoft.com/office/drawing/2014/main" val="1258569730"/>
                    </a:ext>
                  </a:extLst>
                </a:gridCol>
                <a:gridCol w="1355756">
                  <a:extLst>
                    <a:ext uri="{9D8B030D-6E8A-4147-A177-3AD203B41FA5}">
                      <a16:colId xmlns:a16="http://schemas.microsoft.com/office/drawing/2014/main" val="1037026249"/>
                    </a:ext>
                  </a:extLst>
                </a:gridCol>
                <a:gridCol w="2083153">
                  <a:extLst>
                    <a:ext uri="{9D8B030D-6E8A-4147-A177-3AD203B41FA5}">
                      <a16:colId xmlns:a16="http://schemas.microsoft.com/office/drawing/2014/main" val="2900388409"/>
                    </a:ext>
                  </a:extLst>
                </a:gridCol>
                <a:gridCol w="1820171">
                  <a:extLst>
                    <a:ext uri="{9D8B030D-6E8A-4147-A177-3AD203B41FA5}">
                      <a16:colId xmlns:a16="http://schemas.microsoft.com/office/drawing/2014/main" val="556022516"/>
                    </a:ext>
                  </a:extLst>
                </a:gridCol>
              </a:tblGrid>
              <a:tr h="453648"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7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condary Antibodies </a:t>
                      </a:r>
                      <a:endParaRPr lang="en-GB" sz="25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7095" marR="97095" marT="134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7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mpany</a:t>
                      </a:r>
                      <a:endParaRPr lang="en-GB" sz="25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7095" marR="97095" marT="134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7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ost</a:t>
                      </a:r>
                      <a:endParaRPr lang="en-GB" sz="25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7095" marR="97095" marT="134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7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ilution (WB) </a:t>
                      </a:r>
                      <a:endParaRPr lang="en-GB" sz="25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7095" marR="97095" marT="134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7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ilution (IF)</a:t>
                      </a:r>
                      <a:endParaRPr lang="en-GB" sz="25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7095" marR="97095" marT="134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40489492"/>
                  </a:ext>
                </a:extLst>
              </a:tr>
              <a:tr h="453648"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7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nti-rabbit IgG HRP</a:t>
                      </a:r>
                      <a:endParaRPr lang="en-GB" sz="25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7095" marR="97095" marT="134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7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ell Signalling (7074S)</a:t>
                      </a:r>
                      <a:endParaRPr lang="en-GB" sz="25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7095" marR="97095" marT="134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7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oat</a:t>
                      </a:r>
                      <a:endParaRPr lang="en-GB" sz="25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7095" marR="97095" marT="134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7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:5000</a:t>
                      </a:r>
                      <a:endParaRPr lang="en-GB" sz="25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7095" marR="97095" marT="134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7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/A</a:t>
                      </a:r>
                      <a:endParaRPr lang="en-GB" sz="25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7095" marR="97095" marT="134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0293425"/>
                  </a:ext>
                </a:extLst>
              </a:tr>
              <a:tr h="453648"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7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nti-mouse IgG HRP</a:t>
                      </a:r>
                      <a:endParaRPr lang="en-GB" sz="25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7095" marR="97095" marT="134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7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ell Signalling (7076S)</a:t>
                      </a:r>
                      <a:endParaRPr lang="en-GB" sz="25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7095" marR="97095" marT="134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7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orse</a:t>
                      </a:r>
                      <a:endParaRPr lang="en-GB" sz="25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7095" marR="97095" marT="134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7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:5000</a:t>
                      </a:r>
                      <a:endParaRPr lang="en-GB" sz="25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7095" marR="97095" marT="134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7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/A</a:t>
                      </a:r>
                      <a:endParaRPr lang="en-GB" sz="25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7095" marR="97095" marT="134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28400278"/>
                  </a:ext>
                </a:extLst>
              </a:tr>
              <a:tr h="842026"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7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lexa Fluor 488 donkey anti-rabbit</a:t>
                      </a:r>
                      <a:endParaRPr lang="en-GB" sz="25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7095" marR="97095" marT="134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700" b="0" i="0" u="none" strike="noStrike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hermo-Fischer (A-21206)</a:t>
                      </a:r>
                      <a:endParaRPr lang="en-GB" sz="25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7095" marR="97095" marT="134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7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onkey</a:t>
                      </a:r>
                      <a:endParaRPr lang="en-GB" sz="25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7095" marR="97095" marT="134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7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/A</a:t>
                      </a:r>
                      <a:endParaRPr lang="en-GB" sz="25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7095" marR="97095" marT="134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7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:200</a:t>
                      </a:r>
                      <a:endParaRPr lang="en-GB" sz="25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7095" marR="97095" marT="134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12704379"/>
                  </a:ext>
                </a:extLst>
              </a:tr>
              <a:tr h="842026"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7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lexa Fluor 568 donkey anti-mouse</a:t>
                      </a:r>
                      <a:endParaRPr lang="en-GB" sz="25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7095" marR="97095" marT="134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700" b="0" i="0" u="none" strike="noStrike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hermo-Fischer (A-10037)</a:t>
                      </a:r>
                      <a:endParaRPr lang="en-GB" sz="25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7095" marR="97095" marT="134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7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onkey </a:t>
                      </a:r>
                      <a:endParaRPr lang="en-GB" sz="25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7095" marR="97095" marT="134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7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/A</a:t>
                      </a:r>
                      <a:endParaRPr lang="en-GB" sz="25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7095" marR="97095" marT="134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7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:200</a:t>
                      </a:r>
                      <a:endParaRPr lang="en-GB" sz="25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7095" marR="97095" marT="134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86737005"/>
                  </a:ext>
                </a:extLst>
              </a:tr>
              <a:tr h="842026"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7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lexa Fluor 568 donkey anti-rabbit</a:t>
                      </a:r>
                      <a:endParaRPr lang="en-GB" sz="25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7095" marR="97095" marT="134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7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hermo-Fischer (A-10042)</a:t>
                      </a:r>
                      <a:endParaRPr lang="en-GB" sz="25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7095" marR="97095" marT="134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7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onkey </a:t>
                      </a:r>
                      <a:endParaRPr lang="en-GB" sz="25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7095" marR="97095" marT="134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7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GB" sz="25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7095" marR="97095" marT="134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7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:200</a:t>
                      </a:r>
                      <a:endParaRPr lang="en-GB" sz="25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7095" marR="97095" marT="134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6686784"/>
                  </a:ext>
                </a:extLst>
              </a:tr>
              <a:tr h="842026"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7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lexa Fluor 647 donkey anti-mouse </a:t>
                      </a:r>
                      <a:endParaRPr lang="en-GB" sz="25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7095" marR="97095" marT="134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7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hermo-Fischer (A-31571)</a:t>
                      </a:r>
                      <a:endParaRPr lang="en-GB" sz="25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7095" marR="97095" marT="134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7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onkey </a:t>
                      </a:r>
                      <a:endParaRPr lang="en-GB" sz="25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7095" marR="97095" marT="134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7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/A</a:t>
                      </a:r>
                      <a:endParaRPr lang="en-GB" sz="25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7095" marR="97095" marT="134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7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:200</a:t>
                      </a:r>
                      <a:endParaRPr lang="en-GB" sz="25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7095" marR="97095" marT="134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63486020"/>
                  </a:ext>
                </a:extLst>
              </a:tr>
              <a:tr h="842026"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7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lexa Fluor 647 donkey anti-rabbit</a:t>
                      </a:r>
                      <a:endParaRPr lang="en-GB" sz="25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7095" marR="97095" marT="134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7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hermo-Fischer (A-31573)</a:t>
                      </a:r>
                      <a:endParaRPr lang="en-GB" sz="25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7095" marR="97095" marT="134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7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onkey </a:t>
                      </a:r>
                      <a:endParaRPr lang="en-GB" sz="25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7095" marR="97095" marT="134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700" b="0" i="0" u="none" strike="noStrike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/A</a:t>
                      </a:r>
                      <a:endParaRPr lang="en-GB" sz="25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7095" marR="97095" marT="134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700" b="0" i="0" u="none" strike="noStrike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:200</a:t>
                      </a:r>
                      <a:endParaRPr lang="en-GB" sz="25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7095" marR="97095" marT="134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98215031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F600C690-CC99-AF30-A5B4-6C164CC86C80}"/>
              </a:ext>
            </a:extLst>
          </p:cNvPr>
          <p:cNvSpPr txBox="1"/>
          <p:nvPr/>
        </p:nvSpPr>
        <p:spPr>
          <a:xfrm>
            <a:off x="209006" y="6413863"/>
            <a:ext cx="20769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able 2</a:t>
            </a:r>
          </a:p>
        </p:txBody>
      </p:sp>
    </p:spTree>
    <p:extLst>
      <p:ext uri="{BB962C8B-B14F-4D97-AF65-F5344CB8AC3E}">
        <p14:creationId xmlns:p14="http://schemas.microsoft.com/office/powerpoint/2010/main" val="63456263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268BB984-6B38-F986-1670-A825B47FBC8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47371" y="221403"/>
            <a:ext cx="6713317" cy="6628527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396CE87-6B43-323E-C4C6-A5C0F8C9CE9C}"/>
              </a:ext>
            </a:extLst>
          </p:cNvPr>
          <p:cNvSpPr txBox="1"/>
          <p:nvPr/>
        </p:nvSpPr>
        <p:spPr>
          <a:xfrm>
            <a:off x="209006" y="6413863"/>
            <a:ext cx="20769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1</a:t>
            </a:r>
          </a:p>
        </p:txBody>
      </p:sp>
    </p:spTree>
    <p:extLst>
      <p:ext uri="{BB962C8B-B14F-4D97-AF65-F5344CB8AC3E}">
        <p14:creationId xmlns:p14="http://schemas.microsoft.com/office/powerpoint/2010/main" val="15489261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D1423853-7BCC-6F77-082A-0489679231E0}"/>
              </a:ext>
            </a:extLst>
          </p:cNvPr>
          <p:cNvSpPr txBox="1"/>
          <p:nvPr/>
        </p:nvSpPr>
        <p:spPr>
          <a:xfrm>
            <a:off x="209006" y="6413863"/>
            <a:ext cx="20769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2</a:t>
            </a:r>
          </a:p>
        </p:txBody>
      </p:sp>
      <p:grpSp>
        <p:nvGrpSpPr>
          <p:cNvPr id="20" name="Group 19">
            <a:extLst>
              <a:ext uri="{FF2B5EF4-FFF2-40B4-BE49-F238E27FC236}">
                <a16:creationId xmlns:a16="http://schemas.microsoft.com/office/drawing/2014/main" id="{898C4FD2-06CF-EE63-CC81-628C665D7F8E}"/>
              </a:ext>
            </a:extLst>
          </p:cNvPr>
          <p:cNvGrpSpPr/>
          <p:nvPr/>
        </p:nvGrpSpPr>
        <p:grpSpPr>
          <a:xfrm>
            <a:off x="3603973" y="456012"/>
            <a:ext cx="5194875" cy="5945976"/>
            <a:chOff x="3603973" y="456012"/>
            <a:chExt cx="5194875" cy="5945976"/>
          </a:xfrm>
        </p:grpSpPr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D24A719D-0CBF-927E-C387-84CC730C4F1A}"/>
                </a:ext>
              </a:extLst>
            </p:cNvPr>
            <p:cNvGrpSpPr/>
            <p:nvPr/>
          </p:nvGrpSpPr>
          <p:grpSpPr>
            <a:xfrm>
              <a:off x="3616854" y="456012"/>
              <a:ext cx="5181994" cy="5945976"/>
              <a:chOff x="1021137" y="258721"/>
              <a:chExt cx="5181994" cy="5945976"/>
            </a:xfrm>
          </p:grpSpPr>
          <p:pic>
            <p:nvPicPr>
              <p:cNvPr id="3" name="Picture 2" descr="A close-up of a microscope&#10;&#10;Description automatically generated">
                <a:extLst>
                  <a:ext uri="{FF2B5EF4-FFF2-40B4-BE49-F238E27FC236}">
                    <a16:creationId xmlns:a16="http://schemas.microsoft.com/office/drawing/2014/main" id="{1EED6BDB-7DDF-B951-FE79-EDB718036C4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21137" y="258721"/>
                <a:ext cx="2560001" cy="1440000"/>
              </a:xfrm>
              <a:prstGeom prst="rect">
                <a:avLst/>
              </a:prstGeom>
            </p:spPr>
          </p:pic>
          <p:pic>
            <p:nvPicPr>
              <p:cNvPr id="4" name="Picture 3" descr="A close-up of a microscope&#10;&#10;Description automatically generated">
                <a:extLst>
                  <a:ext uri="{FF2B5EF4-FFF2-40B4-BE49-F238E27FC236}">
                    <a16:creationId xmlns:a16="http://schemas.microsoft.com/office/drawing/2014/main" id="{2B6DB84A-51EB-94B2-067D-8DEEAABB5B7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643130" y="258721"/>
                <a:ext cx="2560001" cy="1440000"/>
              </a:xfrm>
              <a:prstGeom prst="rect">
                <a:avLst/>
              </a:prstGeom>
            </p:spPr>
          </p:pic>
          <p:pic>
            <p:nvPicPr>
              <p:cNvPr id="5" name="Picture 4" descr="A close-up of a microscope&#10;&#10;Description automatically generated">
                <a:extLst>
                  <a:ext uri="{FF2B5EF4-FFF2-40B4-BE49-F238E27FC236}">
                    <a16:creationId xmlns:a16="http://schemas.microsoft.com/office/drawing/2014/main" id="{31E78BFE-658A-08AB-20F3-77624C29BE3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21138" y="1760713"/>
                <a:ext cx="2560000" cy="1440000"/>
              </a:xfrm>
              <a:prstGeom prst="rect">
                <a:avLst/>
              </a:prstGeom>
            </p:spPr>
          </p:pic>
          <p:pic>
            <p:nvPicPr>
              <p:cNvPr id="6" name="Picture 5" descr="A close-up of a microscope&#10;&#10;Description automatically generated">
                <a:extLst>
                  <a:ext uri="{FF2B5EF4-FFF2-40B4-BE49-F238E27FC236}">
                    <a16:creationId xmlns:a16="http://schemas.microsoft.com/office/drawing/2014/main" id="{CC00ED24-F40E-1DBE-41AD-AAEA8BEAE9F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643130" y="1760713"/>
                <a:ext cx="2560000" cy="1440000"/>
              </a:xfrm>
              <a:prstGeom prst="rect">
                <a:avLst/>
              </a:prstGeom>
            </p:spPr>
          </p:pic>
          <p:pic>
            <p:nvPicPr>
              <p:cNvPr id="7" name="Picture 6" descr="A close-up of a grey surface&#10;&#10;Description automatically generated">
                <a:extLst>
                  <a:ext uri="{FF2B5EF4-FFF2-40B4-BE49-F238E27FC236}">
                    <a16:creationId xmlns:a16="http://schemas.microsoft.com/office/drawing/2014/main" id="{5BA43CF8-5C0B-994E-EF3F-80401E7DE1C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21137" y="3262705"/>
                <a:ext cx="2560001" cy="1440000"/>
              </a:xfrm>
              <a:prstGeom prst="rect">
                <a:avLst/>
              </a:prstGeom>
            </p:spPr>
          </p:pic>
          <p:pic>
            <p:nvPicPr>
              <p:cNvPr id="8" name="Picture 7" descr="A close-up of a microscope&#10;&#10;Description automatically generated">
                <a:extLst>
                  <a:ext uri="{FF2B5EF4-FFF2-40B4-BE49-F238E27FC236}">
                    <a16:creationId xmlns:a16="http://schemas.microsoft.com/office/drawing/2014/main" id="{415C5CF4-9DE2-F3DF-C069-1C132D4DDCF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643130" y="3262705"/>
                <a:ext cx="2560000" cy="1440000"/>
              </a:xfrm>
              <a:prstGeom prst="rect">
                <a:avLst/>
              </a:prstGeom>
            </p:spPr>
          </p:pic>
          <p:pic>
            <p:nvPicPr>
              <p:cNvPr id="9" name="Picture 8" descr="A close-up of a grey surface&#10;&#10;Description automatically generated">
                <a:extLst>
                  <a:ext uri="{FF2B5EF4-FFF2-40B4-BE49-F238E27FC236}">
                    <a16:creationId xmlns:a16="http://schemas.microsoft.com/office/drawing/2014/main" id="{E3C5CE57-6F96-0B77-BC70-F9884AD7FF3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21138" y="4764697"/>
                <a:ext cx="2560000" cy="1440000"/>
              </a:xfrm>
              <a:prstGeom prst="rect">
                <a:avLst/>
              </a:prstGeom>
            </p:spPr>
          </p:pic>
          <p:pic>
            <p:nvPicPr>
              <p:cNvPr id="10" name="Picture 9" descr="A close-up of a microscope&#10;&#10;Description automatically generated">
                <a:extLst>
                  <a:ext uri="{FF2B5EF4-FFF2-40B4-BE49-F238E27FC236}">
                    <a16:creationId xmlns:a16="http://schemas.microsoft.com/office/drawing/2014/main" id="{C2EB41FC-C34F-79ED-C3F4-7B685915F1B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643130" y="4764697"/>
                <a:ext cx="2560000" cy="1440000"/>
              </a:xfrm>
              <a:prstGeom prst="rect">
                <a:avLst/>
              </a:prstGeom>
            </p:spPr>
          </p:pic>
        </p:grp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B5F3E24E-7706-67FA-D81E-7392A3ABCFF8}"/>
                </a:ext>
              </a:extLst>
            </p:cNvPr>
            <p:cNvSpPr txBox="1"/>
            <p:nvPr/>
          </p:nvSpPr>
          <p:spPr>
            <a:xfrm>
              <a:off x="3616853" y="456012"/>
              <a:ext cx="5301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ZA" dirty="0"/>
                <a:t>A1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84523E5B-CA9B-22BB-6C79-2DDF1748545E}"/>
                </a:ext>
              </a:extLst>
            </p:cNvPr>
            <p:cNvSpPr txBox="1"/>
            <p:nvPr/>
          </p:nvSpPr>
          <p:spPr>
            <a:xfrm>
              <a:off x="6238847" y="456012"/>
              <a:ext cx="5301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ZA" dirty="0"/>
                <a:t>A2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15B55E59-F41C-4EC6-D74F-FBAFBA136A94}"/>
                </a:ext>
              </a:extLst>
            </p:cNvPr>
            <p:cNvSpPr txBox="1"/>
            <p:nvPr/>
          </p:nvSpPr>
          <p:spPr>
            <a:xfrm>
              <a:off x="3603973" y="1896012"/>
              <a:ext cx="5301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ZA" dirty="0"/>
                <a:t>B1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1AF16D13-E2B4-C39F-3F41-B9646CCEB956}"/>
                </a:ext>
              </a:extLst>
            </p:cNvPr>
            <p:cNvSpPr txBox="1"/>
            <p:nvPr/>
          </p:nvSpPr>
          <p:spPr>
            <a:xfrm>
              <a:off x="6225967" y="1896012"/>
              <a:ext cx="5301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ZA" dirty="0"/>
                <a:t>B2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FA5AC71A-BFEF-8AAE-D058-803A6D7F64F7}"/>
                </a:ext>
              </a:extLst>
            </p:cNvPr>
            <p:cNvSpPr txBox="1"/>
            <p:nvPr/>
          </p:nvSpPr>
          <p:spPr>
            <a:xfrm>
              <a:off x="3603973" y="3429000"/>
              <a:ext cx="5301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ZA" dirty="0"/>
                <a:t>C1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A35BDAC4-3ACE-1A40-6CF9-06973E1087BB}"/>
                </a:ext>
              </a:extLst>
            </p:cNvPr>
            <p:cNvSpPr txBox="1"/>
            <p:nvPr/>
          </p:nvSpPr>
          <p:spPr>
            <a:xfrm>
              <a:off x="6225967" y="3429000"/>
              <a:ext cx="5301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ZA" dirty="0"/>
                <a:t>C2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4F688E7A-5F05-FD6E-70C0-8DD8FDAA4227}"/>
                </a:ext>
              </a:extLst>
            </p:cNvPr>
            <p:cNvSpPr txBox="1"/>
            <p:nvPr/>
          </p:nvSpPr>
          <p:spPr>
            <a:xfrm>
              <a:off x="3603973" y="4961988"/>
              <a:ext cx="5301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ZA" dirty="0"/>
                <a:t>D1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C7623AB2-A3AA-C86F-0721-69D97DBBED43}"/>
                </a:ext>
              </a:extLst>
            </p:cNvPr>
            <p:cNvSpPr txBox="1"/>
            <p:nvPr/>
          </p:nvSpPr>
          <p:spPr>
            <a:xfrm>
              <a:off x="6225967" y="4930992"/>
              <a:ext cx="5301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ZA" dirty="0"/>
                <a:t>D2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11360443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ADD293C4-56A7-399D-9BF5-3EFBCE09B9C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56773" y="413051"/>
            <a:ext cx="6773916" cy="603189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AB92C1B1-C698-932C-E093-53FF16038EC2}"/>
              </a:ext>
            </a:extLst>
          </p:cNvPr>
          <p:cNvSpPr txBox="1"/>
          <p:nvPr/>
        </p:nvSpPr>
        <p:spPr>
          <a:xfrm>
            <a:off x="209006" y="6413863"/>
            <a:ext cx="20769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3</a:t>
            </a:r>
          </a:p>
        </p:txBody>
      </p:sp>
    </p:spTree>
    <p:extLst>
      <p:ext uri="{BB962C8B-B14F-4D97-AF65-F5344CB8AC3E}">
        <p14:creationId xmlns:p14="http://schemas.microsoft.com/office/powerpoint/2010/main" val="211339065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72482784-60FE-6D67-DDDC-5A6822A7AAC9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112939" y="891251"/>
            <a:ext cx="9796691" cy="4510212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A9F3B68B-3A3F-F455-9DA3-8FE1FB8A3E37}"/>
              </a:ext>
            </a:extLst>
          </p:cNvPr>
          <p:cNvSpPr txBox="1"/>
          <p:nvPr/>
        </p:nvSpPr>
        <p:spPr>
          <a:xfrm>
            <a:off x="209006" y="6413863"/>
            <a:ext cx="20769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4</a:t>
            </a:r>
          </a:p>
        </p:txBody>
      </p:sp>
    </p:spTree>
    <p:extLst>
      <p:ext uri="{BB962C8B-B14F-4D97-AF65-F5344CB8AC3E}">
        <p14:creationId xmlns:p14="http://schemas.microsoft.com/office/powerpoint/2010/main" val="253493700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application&#10;&#10;Description automatically generated">
            <a:extLst>
              <a:ext uri="{FF2B5EF4-FFF2-40B4-BE49-F238E27FC236}">
                <a16:creationId xmlns:a16="http://schemas.microsoft.com/office/drawing/2014/main" id="{D2F0ADBE-D9D4-FE1D-470A-66D68C883C4C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039"/>
          <a:stretch/>
        </p:blipFill>
        <p:spPr bwMode="auto">
          <a:xfrm>
            <a:off x="995423" y="527774"/>
            <a:ext cx="10034225" cy="5588491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D401318F-CDB0-D22B-FE05-D22CE4AD4A7F}"/>
              </a:ext>
            </a:extLst>
          </p:cNvPr>
          <p:cNvSpPr txBox="1"/>
          <p:nvPr/>
        </p:nvSpPr>
        <p:spPr>
          <a:xfrm>
            <a:off x="209006" y="6413863"/>
            <a:ext cx="20769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5</a:t>
            </a:r>
          </a:p>
        </p:txBody>
      </p:sp>
    </p:spTree>
    <p:extLst>
      <p:ext uri="{BB962C8B-B14F-4D97-AF65-F5344CB8AC3E}">
        <p14:creationId xmlns:p14="http://schemas.microsoft.com/office/powerpoint/2010/main" val="108212170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picture containing text, different&#10;&#10;Description automatically generated">
            <a:extLst>
              <a:ext uri="{FF2B5EF4-FFF2-40B4-BE49-F238E27FC236}">
                <a16:creationId xmlns:a16="http://schemas.microsoft.com/office/drawing/2014/main" id="{B5516D69-132D-4C1D-BA1E-202738FBB4DD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881"/>
          <a:stretch/>
        </p:blipFill>
        <p:spPr bwMode="auto">
          <a:xfrm>
            <a:off x="891251" y="673821"/>
            <a:ext cx="9995631" cy="5510358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FD351E1-A76D-E3B5-A6B7-6322D8DA5E3A}"/>
              </a:ext>
            </a:extLst>
          </p:cNvPr>
          <p:cNvSpPr txBox="1"/>
          <p:nvPr/>
        </p:nvSpPr>
        <p:spPr>
          <a:xfrm>
            <a:off x="209006" y="6413863"/>
            <a:ext cx="20769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6</a:t>
            </a:r>
          </a:p>
        </p:txBody>
      </p:sp>
    </p:spTree>
    <p:extLst>
      <p:ext uri="{BB962C8B-B14F-4D97-AF65-F5344CB8AC3E}">
        <p14:creationId xmlns:p14="http://schemas.microsoft.com/office/powerpoint/2010/main" val="40951140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897</TotalTime>
  <Words>747</Words>
  <Application>Microsoft Macintosh PowerPoint</Application>
  <PresentationFormat>Widescreen</PresentationFormat>
  <Paragraphs>126</Paragraphs>
  <Slides>8</Slides>
  <Notes>8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4" baseType="lpstr">
      <vt:lpstr>Arial</vt:lpstr>
      <vt:lpstr>Calibri</vt:lpstr>
      <vt:lpstr>Calibri Light</vt:lpstr>
      <vt:lpstr>Cambria Math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 Tables</dc:title>
  <dc:creator>Heathcote, N, Me [20186282@sun.ac.za]</dc:creator>
  <cp:lastModifiedBy>Loos, B, Prof [bloos@sun.ac.za]</cp:lastModifiedBy>
  <cp:revision>8</cp:revision>
  <dcterms:created xsi:type="dcterms:W3CDTF">2023-04-17T08:35:23Z</dcterms:created>
  <dcterms:modified xsi:type="dcterms:W3CDTF">2024-07-05T14:59:45Z</dcterms:modified>
</cp:coreProperties>
</file>